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286" r:id="rId2"/>
  </p:sldIdLst>
  <p:sldSz cx="6858000" cy="9144000" type="screen4x3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D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6306" autoAdjust="0"/>
  </p:normalViewPr>
  <p:slideViewPr>
    <p:cSldViewPr snapToGrid="0">
      <p:cViewPr varScale="1">
        <p:scale>
          <a:sx n="76" d="100"/>
          <a:sy n="76" d="100"/>
        </p:scale>
        <p:origin x="3210" y="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82" d="100"/>
        <a:sy n="8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ysu.CORP\Documents\ITI-Manuscript\JRC_2015_mice_paper\Data_Figures\Supplemental%20figure\14-024\14-024_all%20IgG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ysu.CORP\Documents\ITI-Manuscript\JRC_2015_mice_paper\Data_Figures\Supplemental%20figure\14-024\14-024_all%20Ig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nti-JRC IgG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475065616797898"/>
          <c:y val="0.12441088503793261"/>
          <c:w val="0.79734490575041761"/>
          <c:h val="0.754300816564596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JRC_EP_titers!$C$1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H$15:$H$16</c:f>
                <c:numCache>
                  <c:formatCode>General</c:formatCode>
                  <c:ptCount val="2"/>
                  <c:pt idx="0">
                    <c:v>489.89794855663564</c:v>
                  </c:pt>
                  <c:pt idx="1">
                    <c:v>3521.3633723318017</c:v>
                  </c:pt>
                </c:numCache>
              </c:numRef>
            </c:plus>
            <c:minus>
              <c:numRef>
                <c:f>JRC_EP_titers!$H$15:$H$16</c:f>
                <c:numCache>
                  <c:formatCode>General</c:formatCode>
                  <c:ptCount val="2"/>
                  <c:pt idx="0">
                    <c:v>489.89794855663564</c:v>
                  </c:pt>
                  <c:pt idx="1">
                    <c:v>3521.363372331801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15:$B$16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C$15:$C$16</c:f>
              <c:numCache>
                <c:formatCode>General</c:formatCode>
                <c:ptCount val="2"/>
                <c:pt idx="0">
                  <c:v>1200</c:v>
                </c:pt>
                <c:pt idx="1">
                  <c:v>4000</c:v>
                </c:pt>
              </c:numCache>
            </c:numRef>
          </c:val>
        </c:ser>
        <c:ser>
          <c:idx val="1"/>
          <c:order val="1"/>
          <c:tx>
            <c:strRef>
              <c:f>JRC_EP_titers!$D$14</c:f>
              <c:strCache>
                <c:ptCount val="1"/>
                <c:pt idx="0">
                  <c:v>BioJector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I$15:$I$16</c:f>
                <c:numCache>
                  <c:formatCode>General</c:formatCode>
                  <c:ptCount val="2"/>
                  <c:pt idx="0">
                    <c:v>9748.8460855631529</c:v>
                  </c:pt>
                  <c:pt idx="1">
                    <c:v>30737.599125501001</c:v>
                  </c:pt>
                </c:numCache>
              </c:numRef>
            </c:plus>
            <c:minus>
              <c:numRef>
                <c:f>JRC_EP_titers!$I$15:$I$16</c:f>
                <c:numCache>
                  <c:formatCode>General</c:formatCode>
                  <c:ptCount val="2"/>
                  <c:pt idx="0">
                    <c:v>9748.8460855631529</c:v>
                  </c:pt>
                  <c:pt idx="1">
                    <c:v>30737.59912550100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15:$B$16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D$15:$D$16</c:f>
              <c:numCache>
                <c:formatCode>General</c:formatCode>
                <c:ptCount val="2"/>
                <c:pt idx="0">
                  <c:v>16800</c:v>
                </c:pt>
                <c:pt idx="1">
                  <c:v>40000</c:v>
                </c:pt>
              </c:numCache>
            </c:numRef>
          </c:val>
        </c:ser>
        <c:ser>
          <c:idx val="2"/>
          <c:order val="2"/>
          <c:tx>
            <c:strRef>
              <c:f>JRC_EP_titers!$E$14</c:f>
              <c:strCache>
                <c:ptCount val="1"/>
                <c:pt idx="0">
                  <c:v>ID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J$15:$J$16</c:f>
                <c:numCache>
                  <c:formatCode>General</c:formatCode>
                  <c:ptCount val="2"/>
                  <c:pt idx="0">
                    <c:v>11047.372739454591</c:v>
                  </c:pt>
                  <c:pt idx="1">
                    <c:v>24972.874172678734</c:v>
                  </c:pt>
                </c:numCache>
              </c:numRef>
            </c:plus>
            <c:minus>
              <c:numRef>
                <c:f>JRC_EP_titers!$J$15:$J$16</c:f>
                <c:numCache>
                  <c:formatCode>General</c:formatCode>
                  <c:ptCount val="2"/>
                  <c:pt idx="0">
                    <c:v>11047.372739454591</c:v>
                  </c:pt>
                  <c:pt idx="1">
                    <c:v>24972.87417267873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15:$B$16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E$15:$E$16</c:f>
              <c:numCache>
                <c:formatCode>General</c:formatCode>
                <c:ptCount val="2"/>
                <c:pt idx="0">
                  <c:v>29333.333333333332</c:v>
                </c:pt>
                <c:pt idx="1">
                  <c:v>47333.3333333333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093176"/>
        <c:axId val="156097656"/>
      </c:barChart>
      <c:catAx>
        <c:axId val="156093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6097656"/>
        <c:crosses val="autoZero"/>
        <c:auto val="1"/>
        <c:lblAlgn val="ctr"/>
        <c:lblOffset val="100"/>
        <c:noMultiLvlLbl val="0"/>
      </c:catAx>
      <c:valAx>
        <c:axId val="156097656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6093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nti-JRC IgG2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747792889525174"/>
          <c:y val="0.12441088503793261"/>
          <c:w val="0.78219339059890258"/>
          <c:h val="0.740411927675707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JRC_EP_titers!$C$20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H$21:$H$2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400</c:v>
                  </c:pt>
                </c:numCache>
              </c:numRef>
            </c:plus>
            <c:minus>
              <c:numRef>
                <c:f>JRC_EP_titers!$H$21:$H$2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40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21:$B$22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C$21:$C$22</c:f>
              <c:numCache>
                <c:formatCode>General</c:formatCode>
                <c:ptCount val="2"/>
                <c:pt idx="0">
                  <c:v>0</c:v>
                </c:pt>
                <c:pt idx="1">
                  <c:v>400</c:v>
                </c:pt>
              </c:numCache>
            </c:numRef>
          </c:val>
        </c:ser>
        <c:ser>
          <c:idx val="1"/>
          <c:order val="1"/>
          <c:tx>
            <c:strRef>
              <c:f>JRC_EP_titers!$D$20</c:f>
              <c:strCache>
                <c:ptCount val="1"/>
                <c:pt idx="0">
                  <c:v>BioJector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I$21:$I$22</c:f>
                <c:numCache>
                  <c:formatCode>General</c:formatCode>
                  <c:ptCount val="2"/>
                  <c:pt idx="0">
                    <c:v>92064.325338319832</c:v>
                  </c:pt>
                  <c:pt idx="1">
                    <c:v>278599.06676082028</c:v>
                  </c:pt>
                </c:numCache>
              </c:numRef>
            </c:plus>
            <c:minus>
              <c:numRef>
                <c:f>JRC_EP_titers!$I$21:$I$22</c:f>
                <c:numCache>
                  <c:formatCode>General</c:formatCode>
                  <c:ptCount val="2"/>
                  <c:pt idx="0">
                    <c:v>92064.325338319832</c:v>
                  </c:pt>
                  <c:pt idx="1">
                    <c:v>278599.0667608202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21:$B$22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D$21:$D$22</c:f>
              <c:numCache>
                <c:formatCode>General</c:formatCode>
                <c:ptCount val="2"/>
                <c:pt idx="0">
                  <c:v>136800</c:v>
                </c:pt>
                <c:pt idx="1">
                  <c:v>403200</c:v>
                </c:pt>
              </c:numCache>
            </c:numRef>
          </c:val>
        </c:ser>
        <c:ser>
          <c:idx val="2"/>
          <c:order val="2"/>
          <c:tx>
            <c:strRef>
              <c:f>JRC_EP_titers!$E$20</c:f>
              <c:strCache>
                <c:ptCount val="1"/>
                <c:pt idx="0">
                  <c:v>ID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JRC_EP_titers!$J$21:$J$22</c:f>
                <c:numCache>
                  <c:formatCode>General</c:formatCode>
                  <c:ptCount val="2"/>
                  <c:pt idx="0">
                    <c:v>237509.15771818152</c:v>
                  </c:pt>
                  <c:pt idx="1">
                    <c:v>712449.7955021892</c:v>
                  </c:pt>
                </c:numCache>
              </c:numRef>
            </c:plus>
            <c:minus>
              <c:numRef>
                <c:f>JRC_EP_titers!$J$21:$J$22</c:f>
                <c:numCache>
                  <c:formatCode>General</c:formatCode>
                  <c:ptCount val="2"/>
                  <c:pt idx="0">
                    <c:v>237509.15771818152</c:v>
                  </c:pt>
                  <c:pt idx="1">
                    <c:v>712449.795502189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JRC_EP_titers!$B$21:$B$22</c:f>
              <c:numCache>
                <c:formatCode>General</c:formatCode>
                <c:ptCount val="2"/>
                <c:pt idx="0">
                  <c:v>135</c:v>
                </c:pt>
                <c:pt idx="1">
                  <c:v>181</c:v>
                </c:pt>
              </c:numCache>
            </c:numRef>
          </c:cat>
          <c:val>
            <c:numRef>
              <c:f>JRC_EP_titers!$E$21:$E$22</c:f>
              <c:numCache>
                <c:formatCode>General</c:formatCode>
                <c:ptCount val="2"/>
                <c:pt idx="0">
                  <c:v>277000</c:v>
                </c:pt>
                <c:pt idx="1">
                  <c:v>831333.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416992"/>
        <c:axId val="155412904"/>
      </c:barChart>
      <c:catAx>
        <c:axId val="1554169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412904"/>
        <c:crosses val="autoZero"/>
        <c:auto val="1"/>
        <c:lblAlgn val="ctr"/>
        <c:lblOffset val="100"/>
        <c:noMultiLvlLbl val="0"/>
      </c:catAx>
      <c:valAx>
        <c:axId val="155412904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416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C797A4-5BA6-4707-820D-A4C26B7FBE0C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2F75A5-312B-42AA-ADB0-AC459E748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24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738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AD8FE-2CC7-4E98-88D4-B72459E1D417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60788" y="876300"/>
            <a:ext cx="1774825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275" y="3373438"/>
            <a:ext cx="7435850" cy="27606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738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32A20C-DCD4-4A57-88AC-AFFBE9E0C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019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32A20C-DCD4-4A57-88AC-AFFBE9E0CB00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90831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420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65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550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730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253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4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90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34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689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0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83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285995" y="12391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A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85995" y="1109661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B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901565" y="1109661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</a:rPr>
              <a:t>C</a:t>
            </a:r>
          </a:p>
        </p:txBody>
      </p:sp>
      <p:cxnSp>
        <p:nvCxnSpPr>
          <p:cNvPr id="162" name="Straight Arrow Connector 161"/>
          <p:cNvCxnSpPr/>
          <p:nvPr/>
        </p:nvCxnSpPr>
        <p:spPr>
          <a:xfrm>
            <a:off x="721132" y="350919"/>
            <a:ext cx="501996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sp>
        <p:nvSpPr>
          <p:cNvPr id="163" name="TextBox 162"/>
          <p:cNvSpPr txBox="1"/>
          <p:nvPr/>
        </p:nvSpPr>
        <p:spPr>
          <a:xfrm>
            <a:off x="5767260" y="237253"/>
            <a:ext cx="4764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 smtClean="0">
                <a:solidFill>
                  <a:prstClr val="black"/>
                </a:solidFill>
              </a:rPr>
              <a:t>Days </a:t>
            </a:r>
            <a:endParaRPr lang="en-US" sz="1050" kern="0" dirty="0">
              <a:solidFill>
                <a:prstClr val="black"/>
              </a:solidFill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599485" y="220896"/>
            <a:ext cx="256802" cy="453008"/>
            <a:chOff x="586785" y="792396"/>
            <a:chExt cx="256802" cy="453008"/>
          </a:xfrm>
        </p:grpSpPr>
        <p:sp>
          <p:nvSpPr>
            <p:cNvPr id="164" name="Down Arrow 163"/>
            <p:cNvSpPr>
              <a:spLocks/>
            </p:cNvSpPr>
            <p:nvPr/>
          </p:nvSpPr>
          <p:spPr>
            <a:xfrm>
              <a:off x="689590" y="792396"/>
              <a:ext cx="48673" cy="111481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60120">
                <a:defRPr/>
              </a:pPr>
              <a:endParaRPr lang="en-US" sz="1050" kern="0">
                <a:solidFill>
                  <a:prstClr val="white"/>
                </a:solidFill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586785" y="983794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60120">
                <a:defRPr/>
              </a:pPr>
              <a:r>
                <a:rPr lang="en-US" sz="1050" kern="0" dirty="0">
                  <a:solidFill>
                    <a:prstClr val="black"/>
                  </a:solidFill>
                </a:rPr>
                <a:t>0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049939" y="220896"/>
            <a:ext cx="253596" cy="445314"/>
            <a:chOff x="814253" y="792396"/>
            <a:chExt cx="253596" cy="445314"/>
          </a:xfrm>
        </p:grpSpPr>
        <p:sp>
          <p:nvSpPr>
            <p:cNvPr id="166" name="Down Arrow 165"/>
            <p:cNvSpPr>
              <a:spLocks/>
            </p:cNvSpPr>
            <p:nvPr/>
          </p:nvSpPr>
          <p:spPr>
            <a:xfrm>
              <a:off x="915454" y="792396"/>
              <a:ext cx="48673" cy="111481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60120">
                <a:defRPr/>
              </a:pPr>
              <a:endParaRPr lang="en-US" sz="1050" kern="0">
                <a:solidFill>
                  <a:prstClr val="white"/>
                </a:solidFill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814253" y="983794"/>
              <a:ext cx="25359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60120">
                <a:defRPr/>
              </a:pPr>
              <a:r>
                <a:rPr lang="en-US" sz="1050" kern="0" dirty="0" smtClean="0">
                  <a:solidFill>
                    <a:prstClr val="black"/>
                  </a:solidFill>
                </a:rPr>
                <a:t>7</a:t>
              </a:r>
              <a:endParaRPr lang="en-US" sz="105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1497187" y="220896"/>
            <a:ext cx="322524" cy="445314"/>
            <a:chOff x="1005652" y="792396"/>
            <a:chExt cx="322524" cy="445314"/>
          </a:xfrm>
        </p:grpSpPr>
        <p:sp>
          <p:nvSpPr>
            <p:cNvPr id="168" name="Down Arrow 167"/>
            <p:cNvSpPr>
              <a:spLocks/>
            </p:cNvSpPr>
            <p:nvPr/>
          </p:nvSpPr>
          <p:spPr>
            <a:xfrm>
              <a:off x="1141318" y="792396"/>
              <a:ext cx="48673" cy="111481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60120">
                <a:defRPr/>
              </a:pPr>
              <a:endParaRPr lang="en-US" sz="1050" kern="0">
                <a:solidFill>
                  <a:prstClr val="white"/>
                </a:solidFill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1005652" y="983794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60120">
                <a:defRPr/>
              </a:pPr>
              <a:r>
                <a:rPr lang="en-US" sz="1050" kern="0" dirty="0" smtClean="0">
                  <a:solidFill>
                    <a:prstClr val="black"/>
                  </a:solidFill>
                </a:rPr>
                <a:t>14</a:t>
              </a:r>
              <a:endParaRPr lang="en-US" sz="1050" kern="0" dirty="0">
                <a:solidFill>
                  <a:prstClr val="black"/>
                </a:solidFill>
              </a:endParaRPr>
            </a:p>
          </p:txBody>
        </p:sp>
      </p:grpSp>
      <p:sp>
        <p:nvSpPr>
          <p:cNvPr id="174" name="Down Arrow 173"/>
          <p:cNvSpPr/>
          <p:nvPr/>
        </p:nvSpPr>
        <p:spPr>
          <a:xfrm>
            <a:off x="5152812" y="220896"/>
            <a:ext cx="64008" cy="111481"/>
          </a:xfrm>
          <a:prstGeom prst="downArrow">
            <a:avLst/>
          </a:prstGeom>
          <a:solidFill>
            <a:srgbClr val="FF0000"/>
          </a:solidFill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60120">
              <a:defRPr/>
            </a:pPr>
            <a:endParaRPr lang="en-US" sz="1050" kern="0">
              <a:solidFill>
                <a:prstClr val="white"/>
              </a:solidFill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4981681" y="412294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 smtClean="0">
                <a:solidFill>
                  <a:prstClr val="black"/>
                </a:solidFill>
              </a:rPr>
              <a:t>181</a:t>
            </a:r>
            <a:endParaRPr lang="en-US" sz="1050" kern="0" dirty="0">
              <a:solidFill>
                <a:prstClr val="black"/>
              </a:solidFill>
            </a:endParaRPr>
          </a:p>
        </p:txBody>
      </p:sp>
      <p:sp>
        <p:nvSpPr>
          <p:cNvPr id="176" name="Down Arrow 175"/>
          <p:cNvSpPr/>
          <p:nvPr/>
        </p:nvSpPr>
        <p:spPr>
          <a:xfrm>
            <a:off x="3715298" y="220896"/>
            <a:ext cx="64008" cy="111481"/>
          </a:xfrm>
          <a:prstGeom prst="downArrow">
            <a:avLst/>
          </a:prstGeom>
          <a:solidFill>
            <a:srgbClr val="FF0000"/>
          </a:solidFill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60120">
              <a:defRPr/>
            </a:pPr>
            <a:endParaRPr lang="en-US" sz="1050" kern="0">
              <a:solidFill>
                <a:prstClr val="white"/>
              </a:solidFill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3544167" y="412294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 smtClean="0">
                <a:solidFill>
                  <a:prstClr val="black"/>
                </a:solidFill>
              </a:rPr>
              <a:t>135</a:t>
            </a:r>
            <a:endParaRPr lang="en-US" sz="1050" kern="0" dirty="0">
              <a:solidFill>
                <a:prstClr val="black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2601645" y="220895"/>
            <a:ext cx="391454" cy="445315"/>
            <a:chOff x="1864238" y="792395"/>
            <a:chExt cx="391454" cy="445315"/>
          </a:xfrm>
        </p:grpSpPr>
        <p:sp>
          <p:nvSpPr>
            <p:cNvPr id="182" name="Flowchart: Merge 181"/>
            <p:cNvSpPr/>
            <p:nvPr/>
          </p:nvSpPr>
          <p:spPr>
            <a:xfrm>
              <a:off x="2029704" y="792395"/>
              <a:ext cx="97346" cy="111482"/>
            </a:xfrm>
            <a:prstGeom prst="flowChartMerge">
              <a:avLst/>
            </a:prstGeom>
            <a:solidFill>
              <a:srgbClr val="00B0F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60120">
                <a:defRPr/>
              </a:pPr>
              <a:endParaRPr lang="en-US" sz="1050" kern="0">
                <a:solidFill>
                  <a:prstClr val="white"/>
                </a:solidFill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864238" y="983794"/>
              <a:ext cx="3914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60120">
                <a:defRPr/>
              </a:pPr>
              <a:r>
                <a:rPr lang="en-US" sz="1050" kern="0" dirty="0" smtClean="0">
                  <a:solidFill>
                    <a:prstClr val="black"/>
                  </a:solidFill>
                </a:rPr>
                <a:t>100</a:t>
              </a:r>
              <a:endParaRPr lang="en-US" sz="1050" kern="0" dirty="0">
                <a:solidFill>
                  <a:prstClr val="black"/>
                </a:solidFill>
              </a:endParaRPr>
            </a:p>
          </p:txBody>
        </p:sp>
      </p:grpSp>
      <p:sp>
        <p:nvSpPr>
          <p:cNvPr id="188" name="Down Arrow 187"/>
          <p:cNvSpPr>
            <a:spLocks/>
          </p:cNvSpPr>
          <p:nvPr/>
        </p:nvSpPr>
        <p:spPr>
          <a:xfrm>
            <a:off x="943262" y="736469"/>
            <a:ext cx="48673" cy="111481"/>
          </a:xfrm>
          <a:prstGeom prst="downArrow">
            <a:avLst/>
          </a:prstGeom>
          <a:solidFill>
            <a:sysClr val="windowText" lastClr="000000"/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60120">
              <a:defRPr/>
            </a:pPr>
            <a:endParaRPr lang="en-US" sz="1050" kern="0">
              <a:solidFill>
                <a:prstClr val="white"/>
              </a:solidFill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987144" y="653710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>
                <a:solidFill>
                  <a:prstClr val="black"/>
                </a:solidFill>
              </a:rPr>
              <a:t>Vaccination</a:t>
            </a:r>
          </a:p>
        </p:txBody>
      </p:sp>
      <p:sp>
        <p:nvSpPr>
          <p:cNvPr id="190" name="Down Arrow 189"/>
          <p:cNvSpPr/>
          <p:nvPr/>
        </p:nvSpPr>
        <p:spPr>
          <a:xfrm>
            <a:off x="2125100" y="736469"/>
            <a:ext cx="77876" cy="111481"/>
          </a:xfrm>
          <a:prstGeom prst="downArrow">
            <a:avLst/>
          </a:prstGeom>
          <a:solidFill>
            <a:srgbClr val="FF0000"/>
          </a:solidFill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60120">
              <a:defRPr/>
            </a:pPr>
            <a:endParaRPr lang="en-US" sz="1050" kern="0">
              <a:solidFill>
                <a:prstClr val="white"/>
              </a:solidFill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2178402" y="653710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>
                <a:solidFill>
                  <a:prstClr val="black"/>
                </a:solidFill>
              </a:rPr>
              <a:t>Bleed</a:t>
            </a:r>
          </a:p>
        </p:txBody>
      </p:sp>
      <p:sp>
        <p:nvSpPr>
          <p:cNvPr id="192" name="Flowchart: Merge 191"/>
          <p:cNvSpPr/>
          <p:nvPr/>
        </p:nvSpPr>
        <p:spPr>
          <a:xfrm>
            <a:off x="3008295" y="736469"/>
            <a:ext cx="97345" cy="111481"/>
          </a:xfrm>
          <a:prstGeom prst="flowChartMerge">
            <a:avLst/>
          </a:prstGeom>
          <a:solidFill>
            <a:srgbClr val="00B0F0"/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60120">
              <a:defRPr/>
            </a:pPr>
            <a:endParaRPr lang="en-US" sz="1050" kern="0">
              <a:solidFill>
                <a:prstClr val="white"/>
              </a:solidFill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192551" y="653710"/>
            <a:ext cx="112562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60120">
              <a:defRPr/>
            </a:pPr>
            <a:r>
              <a:rPr lang="en-US" sz="1050" kern="0" dirty="0" smtClean="0">
                <a:solidFill>
                  <a:prstClr val="black"/>
                </a:solidFill>
              </a:rPr>
              <a:t>JRC extract/Alum</a:t>
            </a:r>
            <a:endParaRPr lang="en-US" sz="1050" kern="0" dirty="0">
              <a:solidFill>
                <a:prstClr val="black"/>
              </a:solidFill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5929959" y="2226998"/>
            <a:ext cx="714518" cy="853347"/>
            <a:chOff x="5917259" y="2445988"/>
            <a:chExt cx="714518" cy="853347"/>
          </a:xfrm>
        </p:grpSpPr>
        <p:grpSp>
          <p:nvGrpSpPr>
            <p:cNvPr id="14" name="Group 13"/>
            <p:cNvGrpSpPr/>
            <p:nvPr/>
          </p:nvGrpSpPr>
          <p:grpSpPr>
            <a:xfrm>
              <a:off x="5917259" y="2445988"/>
              <a:ext cx="605489" cy="184666"/>
              <a:chOff x="5639231" y="4110989"/>
              <a:chExt cx="605489" cy="184666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5639231" y="4153633"/>
                <a:ext cx="106591" cy="99378"/>
                <a:chOff x="5639231" y="4169217"/>
                <a:chExt cx="106591" cy="99378"/>
              </a:xfrm>
            </p:grpSpPr>
            <p:sp>
              <p:nvSpPr>
                <p:cNvPr id="113" name="Rectangle 51"/>
                <p:cNvSpPr>
                  <a:spLocks noChangeArrowheads="1"/>
                </p:cNvSpPr>
                <p:nvPr/>
              </p:nvSpPr>
              <p:spPr bwMode="auto">
                <a:xfrm>
                  <a:off x="5644651" y="4174357"/>
                  <a:ext cx="95751" cy="89098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4" name="Freeform 52"/>
                <p:cNvSpPr>
                  <a:spLocks noEditPoints="1"/>
                </p:cNvSpPr>
                <p:nvPr/>
              </p:nvSpPr>
              <p:spPr bwMode="auto">
                <a:xfrm>
                  <a:off x="5639231" y="4169217"/>
                  <a:ext cx="106591" cy="99378"/>
                </a:xfrm>
                <a:custGeom>
                  <a:avLst/>
                  <a:gdLst>
                    <a:gd name="T0" fmla="*/ 0 w 976"/>
                    <a:gd name="T1" fmla="*/ 48 h 976"/>
                    <a:gd name="T2" fmla="*/ 48 w 976"/>
                    <a:gd name="T3" fmla="*/ 0 h 976"/>
                    <a:gd name="T4" fmla="*/ 928 w 976"/>
                    <a:gd name="T5" fmla="*/ 0 h 976"/>
                    <a:gd name="T6" fmla="*/ 976 w 976"/>
                    <a:gd name="T7" fmla="*/ 48 h 976"/>
                    <a:gd name="T8" fmla="*/ 976 w 976"/>
                    <a:gd name="T9" fmla="*/ 928 h 976"/>
                    <a:gd name="T10" fmla="*/ 928 w 976"/>
                    <a:gd name="T11" fmla="*/ 976 h 976"/>
                    <a:gd name="T12" fmla="*/ 48 w 976"/>
                    <a:gd name="T13" fmla="*/ 976 h 976"/>
                    <a:gd name="T14" fmla="*/ 0 w 976"/>
                    <a:gd name="T15" fmla="*/ 928 h 976"/>
                    <a:gd name="T16" fmla="*/ 0 w 976"/>
                    <a:gd name="T17" fmla="*/ 48 h 976"/>
                    <a:gd name="T18" fmla="*/ 96 w 976"/>
                    <a:gd name="T19" fmla="*/ 928 h 976"/>
                    <a:gd name="T20" fmla="*/ 48 w 976"/>
                    <a:gd name="T21" fmla="*/ 880 h 976"/>
                    <a:gd name="T22" fmla="*/ 928 w 976"/>
                    <a:gd name="T23" fmla="*/ 880 h 976"/>
                    <a:gd name="T24" fmla="*/ 880 w 976"/>
                    <a:gd name="T25" fmla="*/ 928 h 976"/>
                    <a:gd name="T26" fmla="*/ 880 w 976"/>
                    <a:gd name="T27" fmla="*/ 48 h 976"/>
                    <a:gd name="T28" fmla="*/ 928 w 976"/>
                    <a:gd name="T29" fmla="*/ 96 h 976"/>
                    <a:gd name="T30" fmla="*/ 48 w 976"/>
                    <a:gd name="T31" fmla="*/ 96 h 976"/>
                    <a:gd name="T32" fmla="*/ 96 w 976"/>
                    <a:gd name="T33" fmla="*/ 48 h 976"/>
                    <a:gd name="T34" fmla="*/ 96 w 976"/>
                    <a:gd name="T35" fmla="*/ 928 h 9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97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928" y="0"/>
                      </a:lnTo>
                      <a:cubicBezTo>
                        <a:pt x="955" y="0"/>
                        <a:pt x="976" y="22"/>
                        <a:pt x="976" y="48"/>
                      </a:cubicBezTo>
                      <a:lnTo>
                        <a:pt x="976" y="928"/>
                      </a:lnTo>
                      <a:cubicBezTo>
                        <a:pt x="976" y="955"/>
                        <a:pt x="955" y="976"/>
                        <a:pt x="928" y="976"/>
                      </a:cubicBezTo>
                      <a:lnTo>
                        <a:pt x="48" y="976"/>
                      </a:lnTo>
                      <a:cubicBezTo>
                        <a:pt x="22" y="976"/>
                        <a:pt x="0" y="955"/>
                        <a:pt x="0" y="928"/>
                      </a:cubicBezTo>
                      <a:lnTo>
                        <a:pt x="0" y="48"/>
                      </a:lnTo>
                      <a:close/>
                      <a:moveTo>
                        <a:pt x="96" y="928"/>
                      </a:moveTo>
                      <a:lnTo>
                        <a:pt x="48" y="880"/>
                      </a:lnTo>
                      <a:lnTo>
                        <a:pt x="928" y="880"/>
                      </a:lnTo>
                      <a:lnTo>
                        <a:pt x="880" y="928"/>
                      </a:lnTo>
                      <a:lnTo>
                        <a:pt x="880" y="48"/>
                      </a:lnTo>
                      <a:lnTo>
                        <a:pt x="928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928"/>
                      </a:lnTo>
                      <a:close/>
                    </a:path>
                  </a:pathLst>
                </a:custGeom>
                <a:solidFill>
                  <a:srgbClr val="C00000"/>
                </a:solidFill>
                <a:ln w="1588" cap="flat">
                  <a:solidFill>
                    <a:srgbClr val="C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202" name="Rectangle 53"/>
              <p:cNvSpPr>
                <a:spLocks noChangeArrowheads="1"/>
              </p:cNvSpPr>
              <p:nvPr/>
            </p:nvSpPr>
            <p:spPr bwMode="auto">
              <a:xfrm>
                <a:off x="5783760" y="4110989"/>
                <a:ext cx="460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200" dirty="0" smtClean="0">
                    <a:solidFill>
                      <a:srgbClr val="595959"/>
                    </a:solidFill>
                    <a:latin typeface="Calibri" panose="020F0502020204030204" pitchFamily="34" charset="0"/>
                  </a:rPr>
                  <a:t>Control</a:t>
                </a:r>
                <a:endParaRPr lang="en-US" altLang="en-US" sz="1200" dirty="0" smtClea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5917259" y="2780328"/>
              <a:ext cx="714518" cy="184667"/>
              <a:chOff x="5639228" y="4397071"/>
              <a:chExt cx="714518" cy="184667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5639228" y="4444855"/>
                <a:ext cx="95751" cy="89099"/>
                <a:chOff x="5639228" y="4460505"/>
                <a:chExt cx="95751" cy="89099"/>
              </a:xfrm>
            </p:grpSpPr>
            <p:sp>
              <p:nvSpPr>
                <p:cNvPr id="204" name="Rectangle 55"/>
                <p:cNvSpPr>
                  <a:spLocks noChangeArrowheads="1"/>
                </p:cNvSpPr>
                <p:nvPr/>
              </p:nvSpPr>
              <p:spPr bwMode="auto">
                <a:xfrm>
                  <a:off x="5639228" y="4460505"/>
                  <a:ext cx="95751" cy="89099"/>
                </a:xfrm>
                <a:prstGeom prst="rect">
                  <a:avLst/>
                </a:prstGeom>
                <a:noFill/>
                <a:ln w="9525" cap="flat">
                  <a:solidFill>
                    <a:srgbClr val="002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03" name="Rectangle 54"/>
                <p:cNvSpPr>
                  <a:spLocks noChangeArrowheads="1"/>
                </p:cNvSpPr>
                <p:nvPr/>
              </p:nvSpPr>
              <p:spPr bwMode="auto">
                <a:xfrm>
                  <a:off x="5639228" y="4460505"/>
                  <a:ext cx="95751" cy="89099"/>
                </a:xfrm>
                <a:prstGeom prst="rect">
                  <a:avLst/>
                </a:prstGeom>
                <a:solidFill>
                  <a:srgbClr val="4FD1FF"/>
                </a:solidFill>
                <a:ln>
                  <a:solidFill>
                    <a:srgbClr val="00206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205" name="Rectangle 56"/>
              <p:cNvSpPr>
                <a:spLocks noChangeArrowheads="1"/>
              </p:cNvSpPr>
              <p:nvPr/>
            </p:nvSpPr>
            <p:spPr bwMode="auto">
              <a:xfrm>
                <a:off x="5776537" y="4397071"/>
                <a:ext cx="577209" cy="1846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200" dirty="0" smtClean="0">
                    <a:solidFill>
                      <a:srgbClr val="595959"/>
                    </a:solidFill>
                    <a:latin typeface="Calibri" panose="020F0502020204030204" pitchFamily="34" charset="0"/>
                  </a:rPr>
                  <a:t>BioJector</a:t>
                </a:r>
                <a:endParaRPr lang="en-US" altLang="en-US" sz="1200" dirty="0" smtClea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5917259" y="3114668"/>
              <a:ext cx="270363" cy="184667"/>
              <a:chOff x="5639218" y="4969236"/>
              <a:chExt cx="270363" cy="184667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5639218" y="5016163"/>
                <a:ext cx="95751" cy="90812"/>
                <a:chOff x="5639218" y="5032601"/>
                <a:chExt cx="95751" cy="90812"/>
              </a:xfrm>
            </p:grpSpPr>
            <p:sp>
              <p:nvSpPr>
                <p:cNvPr id="208" name="Rectangle 59"/>
                <p:cNvSpPr>
                  <a:spLocks noChangeArrowheads="1"/>
                </p:cNvSpPr>
                <p:nvPr/>
              </p:nvSpPr>
              <p:spPr bwMode="auto">
                <a:xfrm>
                  <a:off x="5639218" y="5032601"/>
                  <a:ext cx="95751" cy="908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09" name="Rectangle 60"/>
                <p:cNvSpPr>
                  <a:spLocks noChangeArrowheads="1"/>
                </p:cNvSpPr>
                <p:nvPr/>
              </p:nvSpPr>
              <p:spPr bwMode="auto">
                <a:xfrm>
                  <a:off x="5639218" y="5032601"/>
                  <a:ext cx="95751" cy="90812"/>
                </a:xfrm>
                <a:prstGeom prst="rect">
                  <a:avLst/>
                </a:prstGeom>
                <a:solidFill>
                  <a:srgbClr val="7030A0"/>
                </a:solidFill>
                <a:ln w="9525" cap="flat">
                  <a:solidFill>
                    <a:srgbClr val="7030A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210" name="Rectangle 61"/>
              <p:cNvSpPr>
                <a:spLocks noChangeArrowheads="1"/>
              </p:cNvSpPr>
              <p:nvPr/>
            </p:nvSpPr>
            <p:spPr bwMode="auto">
              <a:xfrm>
                <a:off x="5776531" y="4969236"/>
                <a:ext cx="133050" cy="1846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200" dirty="0" smtClean="0">
                    <a:solidFill>
                      <a:srgbClr val="595959"/>
                    </a:solidFill>
                    <a:latin typeface="Calibri" panose="020F0502020204030204" pitchFamily="34" charset="0"/>
                  </a:rPr>
                  <a:t>ID</a:t>
                </a:r>
                <a:endParaRPr lang="en-US" altLang="en-US" sz="1200" dirty="0" smtClean="0">
                  <a:solidFill>
                    <a:prstClr val="black"/>
                  </a:solidFill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 rot="16200000">
            <a:off x="-251943" y="2530561"/>
            <a:ext cx="1210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IgG Antibody Titers </a:t>
            </a:r>
            <a:endParaRPr lang="en-US" sz="1000" dirty="0">
              <a:solidFill>
                <a:prstClr val="black"/>
              </a:solidFill>
            </a:endParaRPr>
          </a:p>
        </p:txBody>
      </p:sp>
      <p:grpSp>
        <p:nvGrpSpPr>
          <p:cNvPr id="307" name="Group 306"/>
          <p:cNvGrpSpPr/>
          <p:nvPr/>
        </p:nvGrpSpPr>
        <p:grpSpPr>
          <a:xfrm>
            <a:off x="2013363" y="220896"/>
            <a:ext cx="322525" cy="445314"/>
            <a:chOff x="1005652" y="792396"/>
            <a:chExt cx="322525" cy="445314"/>
          </a:xfrm>
        </p:grpSpPr>
        <p:sp>
          <p:nvSpPr>
            <p:cNvPr id="308" name="Down Arrow 307"/>
            <p:cNvSpPr>
              <a:spLocks/>
            </p:cNvSpPr>
            <p:nvPr/>
          </p:nvSpPr>
          <p:spPr>
            <a:xfrm>
              <a:off x="1141318" y="792396"/>
              <a:ext cx="48673" cy="111481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60120">
                <a:defRPr/>
              </a:pPr>
              <a:endParaRPr lang="en-US" sz="1050" kern="0">
                <a:solidFill>
                  <a:prstClr val="white"/>
                </a:solidFill>
              </a:endParaRPr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1005652" y="983794"/>
              <a:ext cx="32252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60120">
                <a:defRPr/>
              </a:pPr>
              <a:r>
                <a:rPr lang="en-US" sz="1050" kern="0" dirty="0" smtClean="0">
                  <a:solidFill>
                    <a:prstClr val="black"/>
                  </a:solidFill>
                </a:rPr>
                <a:t>87</a:t>
              </a:r>
              <a:endParaRPr lang="en-US" sz="105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568140" y="1282071"/>
            <a:ext cx="4966644" cy="2743200"/>
            <a:chOff x="611195" y="1717869"/>
            <a:chExt cx="4966644" cy="2743200"/>
          </a:xfrm>
        </p:grpSpPr>
        <p:graphicFrame>
          <p:nvGraphicFramePr>
            <p:cNvPr id="312" name="Chart 311"/>
            <p:cNvGraphicFramePr>
              <a:graphicFrameLocks/>
            </p:cNvGraphicFramePr>
            <p:nvPr>
              <p:extLst/>
            </p:nvPr>
          </p:nvGraphicFramePr>
          <p:xfrm>
            <a:off x="611195" y="1717869"/>
            <a:ext cx="2286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13" name="Chart 312"/>
            <p:cNvGraphicFramePr>
              <a:graphicFrameLocks/>
            </p:cNvGraphicFramePr>
            <p:nvPr>
              <p:extLst/>
            </p:nvPr>
          </p:nvGraphicFramePr>
          <p:xfrm>
            <a:off x="3291839" y="1717869"/>
            <a:ext cx="2286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634908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8</TotalTime>
  <Words>28</Words>
  <Application>Microsoft Office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</dc:creator>
  <cp:lastModifiedBy>Yan Su</cp:lastModifiedBy>
  <cp:revision>484</cp:revision>
  <cp:lastPrinted>2016-03-21T18:45:19Z</cp:lastPrinted>
  <dcterms:created xsi:type="dcterms:W3CDTF">2014-04-15T17:15:57Z</dcterms:created>
  <dcterms:modified xsi:type="dcterms:W3CDTF">2016-03-28T13:07:21Z</dcterms:modified>
</cp:coreProperties>
</file>